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A42E17-BFEE-4B57-9B60-8187704B95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256F1-ED7E-46EE-A456-5D6F07EF3F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0FA71-607B-47B1-AB7F-B933407F39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E7623-07F3-453D-AD62-9078F59BAD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D3C91-87CC-41E2-99FF-C03DBEBCDE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6BCE1-70E1-4C3A-8B16-B2E23B8537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D8C2B9-8901-4563-8E6A-E38584BAE0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F2D69C-6D78-4328-B727-BE20ED5516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9710AA-F9C4-454F-9035-D8E209B0BB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BE6F7-C2C5-4C23-B5E7-5F5656F52D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A300C0-932D-4486-B315-3D17B6A661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DC6D4-1417-4C6A-A47B-C06A7E4EFB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3C914D-D502-4AFF-BB9E-CFB50D138B7E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44680" y="140760"/>
            <a:ext cx="6595920" cy="6021360"/>
            <a:chOff x="544680" y="140760"/>
            <a:chExt cx="6595920" cy="6021360"/>
          </a:xfrm>
        </p:grpSpPr>
        <p:sp>
          <p:nvSpPr>
            <p:cNvPr id="42" name=""/>
            <p:cNvSpPr/>
            <p:nvPr/>
          </p:nvSpPr>
          <p:spPr>
            <a:xfrm rot="16200000">
              <a:off x="683280" y="86616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rot="16200000">
              <a:off x="968760" y="86616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3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rot="16200000">
              <a:off x="1249920" y="86472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rot="16200000">
              <a:off x="1542600" y="864000"/>
              <a:ext cx="78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9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rot="16200000">
              <a:off x="1813320" y="86472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8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6200000">
              <a:off x="2083320" y="86472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4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2373840" y="86472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8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6200000">
              <a:off x="2667600" y="86472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1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6200000">
              <a:off x="2934360" y="86472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6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3216960" y="864720"/>
              <a:ext cx="790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4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6200000">
              <a:off x="3853080" y="707040"/>
              <a:ext cx="1104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Tp365MG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6200000">
              <a:off x="4065840" y="635400"/>
              <a:ext cx="1251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CCF-STTG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6200000">
              <a:off x="4483440" y="743400"/>
              <a:ext cx="1035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17X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44680" y="593640"/>
              <a:ext cx="342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6200000">
              <a:off x="3501360" y="863280"/>
              <a:ext cx="79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4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6200000">
              <a:off x="3763440" y="863280"/>
              <a:ext cx="79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H="1">
              <a:off x="5249880" y="1449360"/>
              <a:ext cx="16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H="1">
              <a:off x="5249880" y="1779480"/>
              <a:ext cx="16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381640" y="1319040"/>
              <a:ext cx="1687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1-MD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373720" y="1644480"/>
              <a:ext cx="1695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2-MD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" name="" descr=""/>
            <p:cNvPicPr/>
            <p:nvPr/>
          </p:nvPicPr>
          <p:blipFill>
            <a:blip r:embed="rId1"/>
            <a:stretch/>
          </p:blipFill>
          <p:spPr>
            <a:xfrm>
              <a:off x="900000" y="1357200"/>
              <a:ext cx="4246560" cy="568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"/>
            <p:cNvSpPr/>
            <p:nvPr/>
          </p:nvSpPr>
          <p:spPr>
            <a:xfrm>
              <a:off x="544680" y="1930320"/>
              <a:ext cx="342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6200000">
              <a:off x="393480" y="2270520"/>
              <a:ext cx="1278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4 wt/mu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rot="16200000">
              <a:off x="1355400" y="2319480"/>
              <a:ext cx="1170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7 wt/mu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rot="16200000">
              <a:off x="1626120" y="2317320"/>
              <a:ext cx="1177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2 wt/mu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rot="16200000">
              <a:off x="2169000" y="2329920"/>
              <a:ext cx="1152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7 mut/mu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rot="16200000">
              <a:off x="2543400" y="2427840"/>
              <a:ext cx="955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33 mut/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rot="16200000">
              <a:off x="2767680" y="2364840"/>
              <a:ext cx="1085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46 wt/mu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rot="16200000">
              <a:off x="3011040" y="2300040"/>
              <a:ext cx="1217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55 mut/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rot="16200000">
              <a:off x="3327840" y="2333160"/>
              <a:ext cx="1152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59 wt/mu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rot="16200000">
              <a:off x="3625920" y="2365920"/>
              <a:ext cx="1086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61 mut/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rot="16200000">
              <a:off x="3889800" y="2331000"/>
              <a:ext cx="1152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03 mut/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rot="16200000">
              <a:off x="4210560" y="2363400"/>
              <a:ext cx="1085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31 mut/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rot="16200000">
              <a:off x="4475520" y="2331000"/>
              <a:ext cx="1149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32 mut/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rot="16200000">
              <a:off x="686160" y="2269080"/>
              <a:ext cx="1276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5 wt/mut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rot="16200000">
              <a:off x="1119600" y="2385000"/>
              <a:ext cx="1044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66 mut/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rot="16200000">
              <a:off x="1965600" y="2381760"/>
              <a:ext cx="1047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64 mut/-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9" name="" descr=""/>
            <p:cNvPicPr/>
            <p:nvPr/>
          </p:nvPicPr>
          <p:blipFill>
            <a:blip r:embed="rId2">
              <a:lum bright="6000"/>
            </a:blip>
            <a:srcRect l="0" t="0" r="16153" b="0"/>
            <a:stretch/>
          </p:blipFill>
          <p:spPr>
            <a:xfrm>
              <a:off x="900000" y="3003480"/>
              <a:ext cx="4295880" cy="631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" descr=""/>
            <p:cNvPicPr/>
            <p:nvPr/>
          </p:nvPicPr>
          <p:blipFill>
            <a:blip r:embed="rId3">
              <a:lum bright="12000"/>
            </a:blip>
            <a:srcRect l="1287" t="0" r="18058" b="35086"/>
            <a:stretch/>
          </p:blipFill>
          <p:spPr>
            <a:xfrm>
              <a:off x="882720" y="4184640"/>
              <a:ext cx="4314600" cy="723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"/>
            <p:cNvSpPr/>
            <p:nvPr/>
          </p:nvSpPr>
          <p:spPr>
            <a:xfrm>
              <a:off x="544680" y="3686040"/>
              <a:ext cx="614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rot="16200000">
              <a:off x="581760" y="3701520"/>
              <a:ext cx="955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rot="16200000">
              <a:off x="797400" y="3669120"/>
              <a:ext cx="1019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rot="16200000">
              <a:off x="1301400" y="3671640"/>
              <a:ext cx="1020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rot="16200000">
              <a:off x="1836360" y="3697560"/>
              <a:ext cx="95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rot="16200000">
              <a:off x="2022120" y="3632400"/>
              <a:ext cx="1084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4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rot="16200000">
              <a:off x="2468160" y="3563640"/>
              <a:ext cx="1214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rot="16200000">
              <a:off x="2246760" y="3600000"/>
              <a:ext cx="114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8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6200000">
              <a:off x="2777760" y="3628800"/>
              <a:ext cx="1083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3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6200000">
              <a:off x="2989800" y="3596760"/>
              <a:ext cx="1149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3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6200000">
              <a:off x="3271680" y="3628800"/>
              <a:ext cx="1083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5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rot="16200000">
              <a:off x="3496680" y="3593880"/>
              <a:ext cx="1148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5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rot="16200000">
              <a:off x="3829680" y="3679200"/>
              <a:ext cx="984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5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16200000">
              <a:off x="4329720" y="3677760"/>
              <a:ext cx="984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9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rot="16200000">
              <a:off x="4575600" y="3677760"/>
              <a:ext cx="984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A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16200000">
              <a:off x="4086720" y="3679200"/>
              <a:ext cx="984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6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16200000">
              <a:off x="1035360" y="3669120"/>
              <a:ext cx="1019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16200000">
              <a:off x="1552320" y="3671640"/>
              <a:ext cx="1020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9" name="" descr=""/>
            <p:cNvPicPr/>
            <p:nvPr/>
          </p:nvPicPr>
          <p:blipFill>
            <a:blip r:embed="rId4">
              <a:lum bright="12000"/>
            </a:blip>
            <a:srcRect l="12094" t="0" r="36719" b="4146"/>
            <a:stretch/>
          </p:blipFill>
          <p:spPr>
            <a:xfrm>
              <a:off x="900000" y="5508720"/>
              <a:ext cx="4295880" cy="633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0" name=""/>
            <p:cNvSpPr/>
            <p:nvPr/>
          </p:nvSpPr>
          <p:spPr>
            <a:xfrm rot="16200000">
              <a:off x="1050840" y="4937400"/>
              <a:ext cx="95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A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16200000">
              <a:off x="1398960" y="4906080"/>
              <a:ext cx="1019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A3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16200000">
              <a:off x="1784520" y="4910760"/>
              <a:ext cx="1019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A1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16200000">
              <a:off x="2207160" y="4934520"/>
              <a:ext cx="952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A5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16200000">
              <a:off x="2535480" y="4869360"/>
              <a:ext cx="1082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2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16200000">
              <a:off x="3239640" y="4832640"/>
              <a:ext cx="1151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2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16200000">
              <a:off x="3640680" y="4866840"/>
              <a:ext cx="1082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16200000">
              <a:off x="4034160" y="4866840"/>
              <a:ext cx="1082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2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16200000">
              <a:off x="4401360" y="4830480"/>
              <a:ext cx="1148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3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16200000">
              <a:off x="574200" y="4838400"/>
              <a:ext cx="1150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GB1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rot="16200000">
              <a:off x="2900880" y="4867920"/>
              <a:ext cx="1082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A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44680" y="4916520"/>
              <a:ext cx="614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H="1">
              <a:off x="5249880" y="3165480"/>
              <a:ext cx="16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H="1">
              <a:off x="5249880" y="3483000"/>
              <a:ext cx="16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381640" y="3035160"/>
              <a:ext cx="1616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1-MD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373720" y="3357720"/>
              <a:ext cx="1623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2-MD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flipH="1">
              <a:off x="5249880" y="5589720"/>
              <a:ext cx="16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H="1">
              <a:off x="5249880" y="5907240"/>
              <a:ext cx="16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381640" y="5452920"/>
              <a:ext cx="1687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1-MD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373720" y="5776920"/>
              <a:ext cx="1766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2-MD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H="1">
              <a:off x="5249880" y="4422600"/>
              <a:ext cx="16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H="1">
              <a:off x="5249880" y="4734000"/>
              <a:ext cx="169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381640" y="4292640"/>
              <a:ext cx="1687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1-MD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373720" y="4608360"/>
              <a:ext cx="16952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P2-MDM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376960" y="144936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(267 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5376960" y="178128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(102 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381640" y="315612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(267 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381640" y="348768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(102 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380200" y="440208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(267 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380200" y="473400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(102 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5384880" y="556884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(267 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5384880" y="5900760"/>
              <a:ext cx="1368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(102 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V="1">
              <a:off x="6093000" y="39492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5877000" y="144360"/>
              <a:ext cx="981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TO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8T08:33:03Z</dcterms:created>
  <dc:creator>Maria</dc:creator>
  <dc:description/>
  <dc:language>en-US</dc:language>
  <cp:lastModifiedBy>Julie Bailey</cp:lastModifiedBy>
  <dcterms:modified xsi:type="dcterms:W3CDTF">2008-07-15T15:11:07Z</dcterms:modified>
  <cp:revision>1</cp:revision>
  <dc:subject/>
  <dc:title>Slide 1</dc:title>
</cp:coreProperties>
</file>